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9AA3D0-9B35-422E-A9ED-625924EAB99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C18204-F2F1-4541-9055-166C0C27581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7331CC-2C5E-433C-941F-45F454723B7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4FBC4C-6F56-4E7A-B3A9-85B2128EE54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273A6B-BF8D-45BB-9E8D-4289C7B297F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C5CB64-4415-4334-8C9E-3378E060CA4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0E2CAD-F319-48C3-9F00-72E4EC1BC48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BF838D-D8D8-4B7F-B7BA-4402B2DA771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A746EB-8168-4C3A-AB23-E53AD3095BA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557CC4-5EBC-4F15-88ED-CE19A80F1D2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CE3944-2F91-4D4B-A959-6B8FAABA550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3FD785-5D55-49C2-9E00-336129BDEF2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25B04F80-FAF6-4E1C-A087-B592C58FC4BD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2728800" y="1847880"/>
          <a:ext cx="3302280" cy="2014560"/>
        </p:xfrm>
        <a:graphic>
          <a:graphicData uri="http://schemas.openxmlformats.org/drawingml/2006/table">
            <a:tbl>
              <a:tblPr/>
              <a:tblGrid>
                <a:gridCol w="825480"/>
                <a:gridCol w="825480"/>
                <a:gridCol w="825480"/>
                <a:gridCol w="825840"/>
              </a:tblGrid>
              <a:tr h="249120">
                <a:tc gridSpan="4"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nb-NO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lpha-synuclein gene expressio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393840"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ybrid cell lin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Mea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tr-TR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Std. Deviatio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i-FI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-valu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28600"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D61</a:t>
                      </a:r>
                      <a:r>
                        <a:rPr b="0" lang="en-US" sz="1200" spc="-1" strike="noStrike" baseline="-25000">
                          <a:solidFill>
                            <a:srgbClr val="000000"/>
                          </a:solidFill>
                          <a:latin typeface="Times New Roman"/>
                        </a:rPr>
                        <a:t>Ori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23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18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28600"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D61</a:t>
                      </a:r>
                      <a:r>
                        <a:rPr b="0" lang="en-US" sz="1200" spc="-1" strike="noStrike" baseline="-25000">
                          <a:solidFill>
                            <a:srgbClr val="000000"/>
                          </a:solidFill>
                          <a:latin typeface="Times New Roman"/>
                        </a:rPr>
                        <a:t>CLB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29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22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43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28600"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D63</a:t>
                      </a:r>
                      <a:r>
                        <a:rPr b="0" lang="en-US" sz="1200" spc="-1" strike="noStrike" baseline="-25000">
                          <a:solidFill>
                            <a:srgbClr val="000000"/>
                          </a:solidFill>
                          <a:latin typeface="Times New Roman"/>
                        </a:rPr>
                        <a:t>Ori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33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23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28600"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D63</a:t>
                      </a:r>
                      <a:r>
                        <a:rPr b="0" lang="en-US" sz="1200" spc="-1" strike="noStrike" baseline="-25000">
                          <a:solidFill>
                            <a:srgbClr val="000000"/>
                          </a:solidFill>
                          <a:latin typeface="Times New Roman"/>
                        </a:rPr>
                        <a:t>CLB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37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25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46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28600"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D67</a:t>
                      </a:r>
                      <a:r>
                        <a:rPr b="0" lang="en-US" sz="1200" spc="-1" strike="noStrike" baseline="-25000">
                          <a:solidFill>
                            <a:srgbClr val="000000"/>
                          </a:solidFill>
                          <a:latin typeface="Times New Roman"/>
                        </a:rPr>
                        <a:t>Ori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34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23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28600"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D67</a:t>
                      </a:r>
                      <a:r>
                        <a:rPr b="0" lang="en-US" sz="1200" spc="-1" strike="noStrike" baseline="-25000">
                          <a:solidFill>
                            <a:srgbClr val="000000"/>
                          </a:solidFill>
                          <a:latin typeface="Times New Roman"/>
                        </a:rPr>
                        <a:t>CLB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30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23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46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11-16T18:05:21Z</dcterms:created>
  <dc:creator>Emily Cronin-Furman</dc:creator>
  <dc:description/>
  <dc:language>en-US</dc:language>
  <cp:lastModifiedBy>Pat Trimmer</cp:lastModifiedBy>
  <dcterms:modified xsi:type="dcterms:W3CDTF">2012-12-11T20:34:50Z</dcterms:modified>
  <cp:revision>2</cp:revision>
  <dc:subject/>
  <dc:title>PowerPoint Presentation</dc:title>
</cp:coreProperties>
</file>